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8" r:id="rId2"/>
  </p:sldIdLst>
  <p:sldSz cx="288004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22" d="100"/>
          <a:sy n="22" d="100"/>
        </p:scale>
        <p:origin x="1891" y="2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534924"/>
            <a:ext cx="24480361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1344752"/>
            <a:ext cx="21600319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726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1016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149975"/>
            <a:ext cx="6210092" cy="1830459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149975"/>
            <a:ext cx="18270270" cy="1830459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955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9230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384888"/>
            <a:ext cx="24840367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4454688"/>
            <a:ext cx="24840367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71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7139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149979"/>
            <a:ext cx="24840367" cy="4174910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294885"/>
            <a:ext cx="12183928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7889827"/>
            <a:ext cx="12183928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294885"/>
            <a:ext cx="12243932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7889827"/>
            <a:ext cx="12243932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46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87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955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109937"/>
            <a:ext cx="14580215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109937"/>
            <a:ext cx="14580215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98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149979"/>
            <a:ext cx="2484036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5749874"/>
            <a:ext cx="2484036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0019564"/>
            <a:ext cx="972014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13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>
            <a:extLst>
              <a:ext uri="{FF2B5EF4-FFF2-40B4-BE49-F238E27FC236}">
                <a16:creationId xmlns:a16="http://schemas.microsoft.com/office/drawing/2014/main" id="{8BCD5E1F-5AAF-D732-D4D5-F615ECE2CC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095" y="665166"/>
            <a:ext cx="27672233" cy="11950662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00D84E8-3794-9D1A-87D9-4A9B017BCA12}"/>
              </a:ext>
            </a:extLst>
          </p:cNvPr>
          <p:cNvSpPr txBox="1"/>
          <p:nvPr/>
        </p:nvSpPr>
        <p:spPr>
          <a:xfrm>
            <a:off x="564095" y="13602113"/>
            <a:ext cx="27672233" cy="22361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32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3: The regulatory phenotype by CD19⁺ B cells from 67NR tumor-bearing mice does not suppress spleen, liver, and lung metastases. (A)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n day 31, metastatic burden was evaluated by clonogenic assays in draining LNs, BM, spleen, lungs, and liver. Data are shown as mean ± SD (n = 3 mice per group), representative of at least two independent experiments. Statistical significance was considered </a:t>
            </a:r>
            <a:r>
              <a:rPr lang="en-US" sz="32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hen p &lt; 0.05; *p &lt; 0.05, **p &lt; 0.01, ***p &lt; 0.001.</a:t>
            </a:r>
            <a:endParaRPr lang="pt-BR" sz="2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6878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01</Words>
  <Application>Microsoft Office PowerPoint</Application>
  <PresentationFormat>Personalizar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Monteiro</dc:creator>
  <cp:lastModifiedBy>Ana Monteiro</cp:lastModifiedBy>
  <cp:revision>3</cp:revision>
  <dcterms:created xsi:type="dcterms:W3CDTF">2025-11-20T17:53:58Z</dcterms:created>
  <dcterms:modified xsi:type="dcterms:W3CDTF">2025-11-20T17:56:51Z</dcterms:modified>
</cp:coreProperties>
</file>